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A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76" d="100"/>
          <a:sy n="76" d="100"/>
        </p:scale>
        <p:origin x="857" y="43"/>
      </p:cViewPr>
      <p:guideLst>
        <p:guide orient="horz" pos="2160"/>
        <p:guide pos="288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E4B7E0-0EBD-40EE-B95D-96C12D93346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B5B23C0-690A-4C5E-AE28-86488349CCA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0B3091-AF93-46B3-AC40-9EC3B17850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22AA1E-18A1-4C39-BC57-39CD3A03A7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512B38-63B7-4D4C-94B8-AB3750FAD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13631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0B7143-837E-47D9-AEA1-68139EB2DD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4C8F6D9-B2C2-42EB-B27A-328CDCFFE7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2FFFFE-61C3-4439-BB98-20795F8D1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5145DC-712B-45B8-B550-9306AB2853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3C8F4D-14F2-4219-BC91-AB2FD4DAC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14150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7CB3490-E0C2-48A7-BA76-0AFC43697B3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156495-AD84-4B8A-AB78-4279650BD89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99A681-BA26-416A-AC0C-2AEB6DDE3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25BB84-D912-437E-82D8-27FD96D52A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A82AE9-5E19-490E-8E26-9337DE92B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963646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F4595F-3706-4AE4-82AA-99C7DFD509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F35E79-726D-477A-8EE1-03A84C4C3F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47549B-0A6C-412E-9652-D668431A89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319F02-863B-42C2-8024-EFE6BADB0B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B7F1D01-C91E-47A1-A871-22A82F283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7843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92E4F6-0462-49F8-ABED-1128195916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A440F6A-394F-4899-8638-7886D9D156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EF64C9-3AC4-43F0-A4F3-2A66F22DB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56BE32-2CF1-4316-8FD5-40E69CC796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60C404-7288-41F4-9E55-7BED67D9CD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38778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1D0932-1215-4DC6-841C-FC579F0FD5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322D27B-0199-4A7C-9322-6CE600C6BCF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5E2640-226A-4497-96B3-EE4586F59FF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EA0A8C6-5440-4604-BBD6-B6A97B87B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C44E7E6-8896-4158-A4B4-4514B533CF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9EC987-021E-4A3F-83A9-AC0EEB7D17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78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2A80A9-6E26-4739-B54C-E72464072F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4E71FE-CCF7-4CBA-95DE-7522A09CC4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D13035-25FA-4CA6-B4DC-E2CA048870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5903F98-679C-4CA4-8753-2BC52FD24B3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3D509FB-10EE-4311-8BC6-4AE2E038934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D1D0019-F2F9-4254-8A82-ABA3A00A08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5BE08CE-3C6E-4CBF-88E3-1A144727FC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1E1FA55-0595-4CC8-A06D-0A04EE13A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273724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50D336-A9C7-4B21-B605-6BA98978D1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EE66DD2-1EAB-4790-B6A5-E9C1EDDFFC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6158BE5-3C33-4C74-8D1D-DBB6FAE57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27AAC3C-2957-48C2-838D-538DC0503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0425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6798A0-F508-4DA0-B7F0-55AF67FB65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6BA312E-251B-4D52-8FC2-F77AC9F1A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5D40E0E-AD5F-41D7-ABA8-383C6D277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19161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0BAD53-20B5-44BC-8F09-58FB8BADCC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4122FD-AEAE-48BF-82BC-5156600F1DD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093ED6F-3DB2-497B-9EA7-36C497AC39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594C62-9F8B-4BFD-B1FB-38AC67147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817E7E8-60DC-4264-B7CE-F75C543F2C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F99E74-D111-4191-857B-2359D6F115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595571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1443596-B963-459C-AA3C-6C827A09F9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98A22E7-FE16-4718-9A24-0F2F07122E8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FF45D8-8B81-4C42-AE8D-7DEC3C7E96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78FE96-0080-4859-BE8D-1DECACDF5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B802EB-EFC4-4DF4-AEC9-D5EBEE322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34B7BAD-3B0D-4DC7-9B02-263EFA431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65035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3BE9861-1CB9-4026-BFA1-78C3EF89157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F5260F-3C88-4D39-9DFB-8420700165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45C9EE-01F4-489C-9945-F5904DC861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5F1552-A0F1-4408-B968-C7CC43AC69ED}" type="datetimeFigureOut">
              <a:rPr lang="en-GB" smtClean="0"/>
              <a:t>06/09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C7D0E2-BCBA-481A-BA21-31BE3BA6B8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A2D964-7AD7-4DFE-A248-63E12A192E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1586B2-E197-4423-9852-02263AA596B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63274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A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microsoft.com/office/2007/relationships/hdphoto" Target="../media/hdphoto5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5" Type="http://schemas.openxmlformats.org/officeDocument/2006/relationships/image" Target="../media/image3.png"/><Relationship Id="rId10" Type="http://schemas.microsoft.com/office/2007/relationships/hdphoto" Target="../media/hdphoto4.wdp"/><Relationship Id="rId4" Type="http://schemas.openxmlformats.org/officeDocument/2006/relationships/image" Target="../media/image2.tiff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104">
            <a:extLst>
              <a:ext uri="{FF2B5EF4-FFF2-40B4-BE49-F238E27FC236}">
                <a16:creationId xmlns:a16="http://schemas.microsoft.com/office/drawing/2014/main" id="{7360A215-2D30-4745-A10F-9ADCE4794E5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794" r="-602" b="2164"/>
          <a:stretch/>
        </p:blipFill>
        <p:spPr>
          <a:xfrm>
            <a:off x="917464" y="518203"/>
            <a:ext cx="3686175" cy="265696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3E43547-6B1B-4EF1-9B9A-0822987ED504}"/>
              </a:ext>
            </a:extLst>
          </p:cNvPr>
          <p:cNvSpPr txBox="1"/>
          <p:nvPr/>
        </p:nvSpPr>
        <p:spPr>
          <a:xfrm>
            <a:off x="-39248" y="1257561"/>
            <a:ext cx="821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LETM1</a:t>
            </a:r>
            <a:endParaRPr lang="en-AT" dirty="0"/>
          </a:p>
        </p:txBody>
      </p:sp>
      <p:pic>
        <p:nvPicPr>
          <p:cNvPr id="5" name="Grafik 6">
            <a:extLst>
              <a:ext uri="{FF2B5EF4-FFF2-40B4-BE49-F238E27FC236}">
                <a16:creationId xmlns:a16="http://schemas.microsoft.com/office/drawing/2014/main" id="{A2BA1226-F9BC-4CC0-89C9-0BF322CEAA7D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898708" y="3761056"/>
            <a:ext cx="3419856" cy="255422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1FFF7602-1C75-44E6-8628-5EDD57DCAFC7}"/>
              </a:ext>
            </a:extLst>
          </p:cNvPr>
          <p:cNvSpPr txBox="1"/>
          <p:nvPr/>
        </p:nvSpPr>
        <p:spPr>
          <a:xfrm>
            <a:off x="-3982" y="4547234"/>
            <a:ext cx="990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TMBIM5</a:t>
            </a:r>
            <a:endParaRPr lang="en-AT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24D1FB41-7690-41D2-9352-38384810EB0C}"/>
              </a:ext>
            </a:extLst>
          </p:cNvPr>
          <p:cNvSpPr/>
          <p:nvPr/>
        </p:nvSpPr>
        <p:spPr>
          <a:xfrm>
            <a:off x="1608229" y="904248"/>
            <a:ext cx="309554" cy="144651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T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4652545-5FA3-42FA-82D0-1B4157606C94}"/>
              </a:ext>
            </a:extLst>
          </p:cNvPr>
          <p:cNvSpPr/>
          <p:nvPr/>
        </p:nvSpPr>
        <p:spPr>
          <a:xfrm>
            <a:off x="6946599" y="4196762"/>
            <a:ext cx="309554" cy="144651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T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B3138C9-E71D-4E2F-823B-B0864BF7AA9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3659" y="517648"/>
            <a:ext cx="3419856" cy="2554224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75B4931C-2EEC-467E-B854-96D6EE0916EB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30926" y="3761056"/>
            <a:ext cx="3419856" cy="2554224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B93523A3-CD71-48A5-A0E7-E570F14E188F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532804" y="517648"/>
            <a:ext cx="3419856" cy="2554224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D0C6BBBD-E3F2-4D58-BC74-08CAFE690AA5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0938" y="3725283"/>
            <a:ext cx="3419856" cy="2554224"/>
          </a:xfrm>
          <a:prstGeom prst="rect">
            <a:avLst/>
          </a:prstGeom>
        </p:spPr>
      </p:pic>
      <p:sp>
        <p:nvSpPr>
          <p:cNvPr id="17" name="Rectangle 16">
            <a:extLst>
              <a:ext uri="{FF2B5EF4-FFF2-40B4-BE49-F238E27FC236}">
                <a16:creationId xmlns:a16="http://schemas.microsoft.com/office/drawing/2014/main" id="{DFEFB0AE-F4AE-4AB6-964A-61791052383A}"/>
              </a:ext>
            </a:extLst>
          </p:cNvPr>
          <p:cNvSpPr/>
          <p:nvPr/>
        </p:nvSpPr>
        <p:spPr>
          <a:xfrm>
            <a:off x="6850141" y="1056648"/>
            <a:ext cx="309554" cy="144651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T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73F1246-F9CE-4B20-922B-047005ADFD6A}"/>
              </a:ext>
            </a:extLst>
          </p:cNvPr>
          <p:cNvSpPr/>
          <p:nvPr/>
        </p:nvSpPr>
        <p:spPr>
          <a:xfrm>
            <a:off x="10298413" y="877452"/>
            <a:ext cx="309554" cy="144651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T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BD51556C-653E-452A-B916-09082043E324}"/>
              </a:ext>
            </a:extLst>
          </p:cNvPr>
          <p:cNvSpPr/>
          <p:nvPr/>
        </p:nvSpPr>
        <p:spPr>
          <a:xfrm>
            <a:off x="10696999" y="4119825"/>
            <a:ext cx="309554" cy="161221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T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5C43CC13-64CD-470A-897A-865955A96E2F}"/>
              </a:ext>
            </a:extLst>
          </p:cNvPr>
          <p:cNvSpPr/>
          <p:nvPr/>
        </p:nvSpPr>
        <p:spPr>
          <a:xfrm>
            <a:off x="3165053" y="4113028"/>
            <a:ext cx="309554" cy="1446510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T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5110179-5F91-43DB-B768-97587D691B7C}"/>
              </a:ext>
            </a:extLst>
          </p:cNvPr>
          <p:cNvSpPr txBox="1"/>
          <p:nvPr/>
        </p:nvSpPr>
        <p:spPr>
          <a:xfrm>
            <a:off x="1527350" y="3225465"/>
            <a:ext cx="2270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Abnova</a:t>
            </a:r>
            <a:r>
              <a:rPr lang="en-GB" dirty="0"/>
              <a:t> #H00003954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4378B57-7BB7-41E1-80A5-22EAADC8BCFD}"/>
              </a:ext>
            </a:extLst>
          </p:cNvPr>
          <p:cNvSpPr txBox="1"/>
          <p:nvPr/>
        </p:nvSpPr>
        <p:spPr>
          <a:xfrm>
            <a:off x="5387606" y="3186948"/>
            <a:ext cx="22709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Aviva systems biology #OAAB12878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65456AA8-CE9B-4D82-81C5-FAE6CFBF8844}"/>
              </a:ext>
            </a:extLst>
          </p:cNvPr>
          <p:cNvSpPr txBox="1"/>
          <p:nvPr/>
        </p:nvSpPr>
        <p:spPr>
          <a:xfrm>
            <a:off x="9358392" y="3203695"/>
            <a:ext cx="2270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anta Cruz #16301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120A705F-07A1-4AB0-90CF-F9FB331BD1AB}"/>
              </a:ext>
            </a:extLst>
          </p:cNvPr>
          <p:cNvSpPr txBox="1"/>
          <p:nvPr/>
        </p:nvSpPr>
        <p:spPr>
          <a:xfrm>
            <a:off x="9375140" y="6330422"/>
            <a:ext cx="2612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erum Oka et al., 2008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3B2F6B4C-B340-4778-A60D-32E5E5818664}"/>
              </a:ext>
            </a:extLst>
          </p:cNvPr>
          <p:cNvSpPr txBox="1"/>
          <p:nvPr/>
        </p:nvSpPr>
        <p:spPr>
          <a:xfrm>
            <a:off x="3550421" y="6333768"/>
            <a:ext cx="2270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Abcam #ab106754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8E9AD89-4785-4D4D-8308-3B9444F9A9D2}"/>
              </a:ext>
            </a:extLst>
          </p:cNvPr>
          <p:cNvSpPr txBox="1"/>
          <p:nvPr/>
        </p:nvSpPr>
        <p:spPr>
          <a:xfrm>
            <a:off x="321547" y="95460"/>
            <a:ext cx="21260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Appendix Figure S1D</a:t>
            </a:r>
          </a:p>
        </p:txBody>
      </p:sp>
    </p:spTree>
    <p:extLst>
      <p:ext uri="{BB962C8B-B14F-4D97-AF65-F5344CB8AC3E}">
        <p14:creationId xmlns:p14="http://schemas.microsoft.com/office/powerpoint/2010/main" val="1499292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9</TotalTime>
  <Words>26</Words>
  <Application>Microsoft Office PowerPoint</Application>
  <PresentationFormat>Widescreen</PresentationFormat>
  <Paragraphs>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mi Elamin Mustafa Mohammed</dc:creator>
  <cp:lastModifiedBy>Sami Elamin Mustafa Mohammed</cp:lastModifiedBy>
  <cp:revision>2</cp:revision>
  <dcterms:created xsi:type="dcterms:W3CDTF">2022-09-06T13:18:41Z</dcterms:created>
  <dcterms:modified xsi:type="dcterms:W3CDTF">2022-09-06T16:27:50Z</dcterms:modified>
</cp:coreProperties>
</file>